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1589" y="-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494BDC-55A3-4BA8-8179-A1E1E6EBEC2C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3934C4-1469-406F-9BD4-BF976DD0557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51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102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25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384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737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435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00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254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927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208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730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1878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A8669E-4234-4773-A97A-100181C0369A}" type="datetimeFigureOut">
              <a:rPr lang="en-GB" smtClean="0"/>
              <a:t>09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CB15B-92ED-4D70-B96F-9D2D255998B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277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0496814"/>
              </p:ext>
            </p:extLst>
          </p:nvPr>
        </p:nvGraphicFramePr>
        <p:xfrm>
          <a:off x="332656" y="611560"/>
          <a:ext cx="6192690" cy="939636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1800201"/>
                <a:gridCol w="1008112"/>
                <a:gridCol w="720080"/>
                <a:gridCol w="2664297"/>
              </a:tblGrid>
              <a:tr h="39099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Study group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Mean ag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Male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Ethnicity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ctr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TB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7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0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00% whit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Active sarcoidosi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0%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60% white, 40% ISC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Controls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0%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20% white, 60% ISC, 20% Chines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785" y="107504"/>
            <a:ext cx="1268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Table </a:t>
            </a:r>
            <a:r>
              <a:rPr lang="en-GB" b="1" dirty="0" smtClean="0"/>
              <a:t>S10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522701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42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om</dc:creator>
  <cp:lastModifiedBy>Bloom</cp:lastModifiedBy>
  <cp:revision>11</cp:revision>
  <dcterms:created xsi:type="dcterms:W3CDTF">2013-03-09T22:22:05Z</dcterms:created>
  <dcterms:modified xsi:type="dcterms:W3CDTF">2013-03-09T22:33:52Z</dcterms:modified>
</cp:coreProperties>
</file>